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16" r:id="rId5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21" userDrawn="1">
          <p15:clr>
            <a:srgbClr val="A4A3A4"/>
          </p15:clr>
        </p15:guide>
        <p15:guide id="2" pos="254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2194" y="86"/>
      </p:cViewPr>
      <p:guideLst>
        <p:guide orient="horz" pos="1321"/>
        <p:guide pos="25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ro Tunheim" userId="a68614e0-426d-4fcb-ad9c-27f20f40851b" providerId="ADAL" clId="{492607E1-F1C0-4CBB-B614-9B2EB5F46EFA}"/>
    <pc:docChg chg="modSld">
      <pc:chgData name="Gro Tunheim" userId="a68614e0-426d-4fcb-ad9c-27f20f40851b" providerId="ADAL" clId="{492607E1-F1C0-4CBB-B614-9B2EB5F46EFA}" dt="2024-08-08T12:27:01.224" v="46" actId="1076"/>
      <pc:docMkLst>
        <pc:docMk/>
      </pc:docMkLst>
      <pc:sldChg chg="addSp modSp mod">
        <pc:chgData name="Gro Tunheim" userId="a68614e0-426d-4fcb-ad9c-27f20f40851b" providerId="ADAL" clId="{492607E1-F1C0-4CBB-B614-9B2EB5F46EFA}" dt="2024-08-08T12:27:01.224" v="46" actId="1076"/>
        <pc:sldMkLst>
          <pc:docMk/>
          <pc:sldMk cId="106003220" sldId="316"/>
        </pc:sldMkLst>
        <pc:spChg chg="mod">
          <ac:chgData name="Gro Tunheim" userId="a68614e0-426d-4fcb-ad9c-27f20f40851b" providerId="ADAL" clId="{492607E1-F1C0-4CBB-B614-9B2EB5F46EFA}" dt="2024-08-08T12:26:38.741" v="38" actId="1035"/>
          <ac:spMkLst>
            <pc:docMk/>
            <pc:sldMk cId="106003220" sldId="316"/>
            <ac:spMk id="4" creationId="{E4E505C2-DB89-F483-8D73-18FB413F1FE8}"/>
          </ac:spMkLst>
        </pc:spChg>
        <pc:spChg chg="add mod">
          <ac:chgData name="Gro Tunheim" userId="a68614e0-426d-4fcb-ad9c-27f20f40851b" providerId="ADAL" clId="{492607E1-F1C0-4CBB-B614-9B2EB5F46EFA}" dt="2024-08-08T12:27:01.224" v="46" actId="1076"/>
          <ac:spMkLst>
            <pc:docMk/>
            <pc:sldMk cId="106003220" sldId="316"/>
            <ac:spMk id="5" creationId="{8135F35A-62DC-86F2-E398-53B19E445A6E}"/>
          </ac:spMkLst>
        </pc:spChg>
        <pc:spChg chg="mod">
          <ac:chgData name="Gro Tunheim" userId="a68614e0-426d-4fcb-ad9c-27f20f40851b" providerId="ADAL" clId="{492607E1-F1C0-4CBB-B614-9B2EB5F46EFA}" dt="2024-08-08T12:26:38.741" v="38" actId="1035"/>
          <ac:spMkLst>
            <pc:docMk/>
            <pc:sldMk cId="106003220" sldId="316"/>
            <ac:spMk id="23" creationId="{F3A93F00-00D8-CC35-F45A-4F6EFABD0E5F}"/>
          </ac:spMkLst>
        </pc:spChg>
        <pc:spChg chg="mod">
          <ac:chgData name="Gro Tunheim" userId="a68614e0-426d-4fcb-ad9c-27f20f40851b" providerId="ADAL" clId="{492607E1-F1C0-4CBB-B614-9B2EB5F46EFA}" dt="2024-08-08T12:26:38.741" v="38" actId="1035"/>
          <ac:spMkLst>
            <pc:docMk/>
            <pc:sldMk cId="106003220" sldId="316"/>
            <ac:spMk id="25" creationId="{6B79FEF3-3B44-47A5-A68E-002FA5A93F14}"/>
          </ac:spMkLst>
        </pc:spChg>
        <pc:graphicFrameChg chg="mod">
          <ac:chgData name="Gro Tunheim" userId="a68614e0-426d-4fcb-ad9c-27f20f40851b" providerId="ADAL" clId="{492607E1-F1C0-4CBB-B614-9B2EB5F46EFA}" dt="2024-08-08T12:26:38.741" v="38" actId="1035"/>
          <ac:graphicFrameMkLst>
            <pc:docMk/>
            <pc:sldMk cId="106003220" sldId="316"/>
            <ac:graphicFrameMk id="3" creationId="{F7702001-5F96-A580-F9AD-8CF84376054F}"/>
          </ac:graphicFrameMkLst>
        </pc:graphicFrameChg>
        <pc:graphicFrameChg chg="mod">
          <ac:chgData name="Gro Tunheim" userId="a68614e0-426d-4fcb-ad9c-27f20f40851b" providerId="ADAL" clId="{492607E1-F1C0-4CBB-B614-9B2EB5F46EFA}" dt="2024-08-08T12:26:38.741" v="38" actId="1035"/>
          <ac:graphicFrameMkLst>
            <pc:docMk/>
            <pc:sldMk cId="106003220" sldId="316"/>
            <ac:graphicFrameMk id="11" creationId="{CBD15462-B866-9679-24DB-768152745DDD}"/>
          </ac:graphicFrameMkLst>
        </pc:graphicFrameChg>
      </pc:sldChg>
    </pc:docChg>
  </pc:docChgLst>
  <pc:docChgLst>
    <pc:chgData name="Gro Tunheim" userId="a68614e0-426d-4fcb-ad9c-27f20f40851b" providerId="ADAL" clId="{CE70EE6C-B501-4081-AC71-637062444245}"/>
    <pc:docChg chg="custSel modSld">
      <pc:chgData name="Gro Tunheim" userId="a68614e0-426d-4fcb-ad9c-27f20f40851b" providerId="ADAL" clId="{CE70EE6C-B501-4081-AC71-637062444245}" dt="2024-05-15T07:21:29.193" v="15" actId="1076"/>
      <pc:docMkLst>
        <pc:docMk/>
      </pc:docMkLst>
      <pc:sldChg chg="addSp modSp mod">
        <pc:chgData name="Gro Tunheim" userId="a68614e0-426d-4fcb-ad9c-27f20f40851b" providerId="ADAL" clId="{CE70EE6C-B501-4081-AC71-637062444245}" dt="2024-05-15T07:21:29.193" v="15" actId="1076"/>
        <pc:sldMkLst>
          <pc:docMk/>
          <pc:sldMk cId="106003220" sldId="316"/>
        </pc:sldMkLst>
        <pc:spChg chg="add mod">
          <ac:chgData name="Gro Tunheim" userId="a68614e0-426d-4fcb-ad9c-27f20f40851b" providerId="ADAL" clId="{CE70EE6C-B501-4081-AC71-637062444245}" dt="2024-05-15T07:21:29.193" v="15" actId="1076"/>
          <ac:spMkLst>
            <pc:docMk/>
            <pc:sldMk cId="106003220" sldId="316"/>
            <ac:spMk id="4" creationId="{E4E505C2-DB89-F483-8D73-18FB413F1FE8}"/>
          </ac:spMkLst>
        </pc:spChg>
      </pc:sldChg>
    </pc:docChg>
  </pc:docChgLst>
  <pc:docChgLst>
    <pc:chgData name="Gro Tunheim" userId="a68614e0-426d-4fcb-ad9c-27f20f40851b" providerId="ADAL" clId="{6312E310-E164-415A-9A38-90EAEF86CE7B}"/>
    <pc:docChg chg="custSel modSld">
      <pc:chgData name="Gro Tunheim" userId="a68614e0-426d-4fcb-ad9c-27f20f40851b" providerId="ADAL" clId="{6312E310-E164-415A-9A38-90EAEF86CE7B}" dt="2024-06-05T07:50:35.440" v="62" actId="1076"/>
      <pc:docMkLst>
        <pc:docMk/>
      </pc:docMkLst>
      <pc:sldChg chg="delSp modSp mod">
        <pc:chgData name="Gro Tunheim" userId="a68614e0-426d-4fcb-ad9c-27f20f40851b" providerId="ADAL" clId="{6312E310-E164-415A-9A38-90EAEF86CE7B}" dt="2024-06-05T07:50:35.440" v="62" actId="1076"/>
        <pc:sldMkLst>
          <pc:docMk/>
          <pc:sldMk cId="106003220" sldId="316"/>
        </pc:sldMkLst>
        <pc:spChg chg="del">
          <ac:chgData name="Gro Tunheim" userId="a68614e0-426d-4fcb-ad9c-27f20f40851b" providerId="ADAL" clId="{6312E310-E164-415A-9A38-90EAEF86CE7B}" dt="2024-06-05T07:07:14.177" v="0" actId="478"/>
          <ac:spMkLst>
            <pc:docMk/>
            <pc:sldMk cId="106003220" sldId="316"/>
            <ac:spMk id="2" creationId="{74BB1EE7-5760-D602-C7FB-17EC41E06342}"/>
          </ac:spMkLst>
        </pc:spChg>
        <pc:spChg chg="mod">
          <ac:chgData name="Gro Tunheim" userId="a68614e0-426d-4fcb-ad9c-27f20f40851b" providerId="ADAL" clId="{6312E310-E164-415A-9A38-90EAEF86CE7B}" dt="2024-06-05T07:50:35.440" v="62" actId="1076"/>
          <ac:spMkLst>
            <pc:docMk/>
            <pc:sldMk cId="106003220" sldId="316"/>
            <ac:spMk id="4" creationId="{E4E505C2-DB89-F483-8D73-18FB413F1FE8}"/>
          </ac:spMkLst>
        </pc:spChg>
        <pc:spChg chg="mod">
          <ac:chgData name="Gro Tunheim" userId="a68614e0-426d-4fcb-ad9c-27f20f40851b" providerId="ADAL" clId="{6312E310-E164-415A-9A38-90EAEF86CE7B}" dt="2024-06-05T07:50:17.110" v="53" actId="1036"/>
          <ac:spMkLst>
            <pc:docMk/>
            <pc:sldMk cId="106003220" sldId="316"/>
            <ac:spMk id="23" creationId="{F3A93F00-00D8-CC35-F45A-4F6EFABD0E5F}"/>
          </ac:spMkLst>
        </pc:spChg>
        <pc:spChg chg="mod">
          <ac:chgData name="Gro Tunheim" userId="a68614e0-426d-4fcb-ad9c-27f20f40851b" providerId="ADAL" clId="{6312E310-E164-415A-9A38-90EAEF86CE7B}" dt="2024-06-05T07:50:29.843" v="61" actId="1036"/>
          <ac:spMkLst>
            <pc:docMk/>
            <pc:sldMk cId="106003220" sldId="316"/>
            <ac:spMk id="25" creationId="{6B79FEF3-3B44-47A5-A68E-002FA5A93F1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op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32E252-A021-4025-9B4B-9E069E79F238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4" name="Plassholder for lysbil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Plassholder for nota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2CBB25-1E36-41D7-A489-373E42AEB05A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83051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>
          <a:xfrm>
            <a:off x="425450" y="1238250"/>
            <a:ext cx="5943600" cy="3343275"/>
          </a:xfrm>
        </p:spPr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96CD0D-2612-4583-9810-904A63DBBDEF}" type="slidenum">
              <a:rPr lang="nb-NO" smtClean="0"/>
              <a:t>1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649183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E97D167-0224-CEEB-4E69-417A2BCF5D4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Undertittel 2">
            <a:extLst>
              <a:ext uri="{FF2B5EF4-FFF2-40B4-BE49-F238E27FC236}">
                <a16:creationId xmlns:a16="http://schemas.microsoft.com/office/drawing/2014/main" id="{1C541714-244E-F289-A94A-74D43A7ADC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047CED5-9377-7927-CBFA-C8B09A87B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89111D5A-C74A-542D-2FC6-4EACF92FE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8EEE3D39-F863-543D-B9A4-F612B9633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938617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4E3559A-A193-D362-E977-AA3A836225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1474CA15-7CF5-42FB-F9D3-7E10E9D95CD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5FAFCA81-9AE2-4779-81EF-12A8948309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3F0A13FB-F5CD-D3A5-9DFA-B3203F3472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E28711C7-4AAA-3B29-745E-58F0618341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72702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>
            <a:extLst>
              <a:ext uri="{FF2B5EF4-FFF2-40B4-BE49-F238E27FC236}">
                <a16:creationId xmlns:a16="http://schemas.microsoft.com/office/drawing/2014/main" id="{731398C7-1110-2ADD-FE0A-028460F791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loddrett tekst 2">
            <a:extLst>
              <a:ext uri="{FF2B5EF4-FFF2-40B4-BE49-F238E27FC236}">
                <a16:creationId xmlns:a16="http://schemas.microsoft.com/office/drawing/2014/main" id="{7F17EF0F-6DCB-15E4-094D-3CD1642824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24D13634-F949-764B-F070-F9FA5209C6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D9C29104-6C95-620D-A642-348E16B8B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5BE24CFB-AF70-B053-6E42-2FEE25A9B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285322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75B47E51-E2B9-57A7-A827-7219F23B0D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4DEBB06-012B-8C34-17FB-4A4F7F5BF4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F7227178-E12A-6B73-10F0-2DCEA9A67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5276C01D-5047-E290-0D89-92495F9D6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AD10B97-28DA-5E90-0AA9-3372A3634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75284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93CB3FD-7473-2611-BFD6-E94F250E40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1610CF76-8F01-22A2-69DC-C876EF204C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8138953F-852E-A68F-030A-F991550E1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E32B2B2B-1DAE-D7F3-F8E4-04FCABF1B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694653C2-73F1-525B-73FC-6C291B97F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347584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A9ED696F-6ADF-91F7-5AF5-1B347707F7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AD07CA11-9ED4-9335-A2FC-F25C496BCD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E10E82AA-C109-F0F4-9F16-C9BE1C1DAF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005805DA-648F-07E0-6A16-1A5161F1D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5C7B5969-E604-00AC-D980-76CAA2BDB5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2CFC37DF-147E-DFA5-8FCB-06EF8FFE5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201982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350D5142-4138-A459-2DC1-C5850468D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15EE25DB-F514-59DC-073D-4E019C18CD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Plassholder for innhold 3">
            <a:extLst>
              <a:ext uri="{FF2B5EF4-FFF2-40B4-BE49-F238E27FC236}">
                <a16:creationId xmlns:a16="http://schemas.microsoft.com/office/drawing/2014/main" id="{58C82742-3934-D35C-1D80-87DB46B6B7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5" name="Plassholder for tekst 4">
            <a:extLst>
              <a:ext uri="{FF2B5EF4-FFF2-40B4-BE49-F238E27FC236}">
                <a16:creationId xmlns:a16="http://schemas.microsoft.com/office/drawing/2014/main" id="{CFB372FF-675C-743C-BC7A-49C3026ECF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Plassholder for innhold 5">
            <a:extLst>
              <a:ext uri="{FF2B5EF4-FFF2-40B4-BE49-F238E27FC236}">
                <a16:creationId xmlns:a16="http://schemas.microsoft.com/office/drawing/2014/main" id="{3B359C48-0C35-0308-640D-E13BDBBE5E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7" name="Plassholder for dato 6">
            <a:extLst>
              <a:ext uri="{FF2B5EF4-FFF2-40B4-BE49-F238E27FC236}">
                <a16:creationId xmlns:a16="http://schemas.microsoft.com/office/drawing/2014/main" id="{99FF875E-C61F-9B44-096F-1217D0D1C3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8" name="Plassholder for bunntekst 7">
            <a:extLst>
              <a:ext uri="{FF2B5EF4-FFF2-40B4-BE49-F238E27FC236}">
                <a16:creationId xmlns:a16="http://schemas.microsoft.com/office/drawing/2014/main" id="{0EBA7D34-27B2-9723-01AC-EC596A8B7B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>
            <a:extLst>
              <a:ext uri="{FF2B5EF4-FFF2-40B4-BE49-F238E27FC236}">
                <a16:creationId xmlns:a16="http://schemas.microsoft.com/office/drawing/2014/main" id="{CCA74685-B5A6-F2B5-6A23-3162478AF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49207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C2906AC0-C39A-E7D0-E7C2-51A5E0D177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dato 2">
            <a:extLst>
              <a:ext uri="{FF2B5EF4-FFF2-40B4-BE49-F238E27FC236}">
                <a16:creationId xmlns:a16="http://schemas.microsoft.com/office/drawing/2014/main" id="{08FDD347-DB90-AC01-39CC-FFE60F6595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4" name="Plassholder for bunntekst 3">
            <a:extLst>
              <a:ext uri="{FF2B5EF4-FFF2-40B4-BE49-F238E27FC236}">
                <a16:creationId xmlns:a16="http://schemas.microsoft.com/office/drawing/2014/main" id="{5463A120-7E7D-DFBA-C57C-750F35AB7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>
            <a:extLst>
              <a:ext uri="{FF2B5EF4-FFF2-40B4-BE49-F238E27FC236}">
                <a16:creationId xmlns:a16="http://schemas.microsoft.com/office/drawing/2014/main" id="{61E2237F-01CB-352B-5024-C78FE4630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794975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>
            <a:extLst>
              <a:ext uri="{FF2B5EF4-FFF2-40B4-BE49-F238E27FC236}">
                <a16:creationId xmlns:a16="http://schemas.microsoft.com/office/drawing/2014/main" id="{849D8796-8B91-E8D0-85E9-0C6377EF7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3" name="Plassholder for bunntekst 2">
            <a:extLst>
              <a:ext uri="{FF2B5EF4-FFF2-40B4-BE49-F238E27FC236}">
                <a16:creationId xmlns:a16="http://schemas.microsoft.com/office/drawing/2014/main" id="{F7163CAF-43D1-4280-6B80-E22D48130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>
            <a:extLst>
              <a:ext uri="{FF2B5EF4-FFF2-40B4-BE49-F238E27FC236}">
                <a16:creationId xmlns:a16="http://schemas.microsoft.com/office/drawing/2014/main" id="{5DD30776-326A-DEC9-72CF-FF95F095EA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73116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BA55CF98-5CD0-E065-8B87-7E902E2C02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innhold 2">
            <a:extLst>
              <a:ext uri="{FF2B5EF4-FFF2-40B4-BE49-F238E27FC236}">
                <a16:creationId xmlns:a16="http://schemas.microsoft.com/office/drawing/2014/main" id="{94373BF3-7161-A6EE-8CA1-2599AA1A33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C356F230-7D88-0A10-79D3-5CA090D470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EDF87BC5-9AD5-3286-C3B8-7B2CB37A6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B12BB14D-7239-ACE7-E722-CC425D2B9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0CE0AF54-FEC9-7337-9462-E9DCDECAB3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760742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>
            <a:extLst>
              <a:ext uri="{FF2B5EF4-FFF2-40B4-BE49-F238E27FC236}">
                <a16:creationId xmlns:a16="http://schemas.microsoft.com/office/drawing/2014/main" id="{47F3DB72-7C8F-1F4C-0454-436E6619E0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bilde 2">
            <a:extLst>
              <a:ext uri="{FF2B5EF4-FFF2-40B4-BE49-F238E27FC236}">
                <a16:creationId xmlns:a16="http://schemas.microsoft.com/office/drawing/2014/main" id="{62BAAAC2-44CA-62D6-C351-CF7482CEFC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>
            <a:extLst>
              <a:ext uri="{FF2B5EF4-FFF2-40B4-BE49-F238E27FC236}">
                <a16:creationId xmlns:a16="http://schemas.microsoft.com/office/drawing/2014/main" id="{993524AA-9AE9-201C-9BBE-E2315613E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Plassholder for dato 4">
            <a:extLst>
              <a:ext uri="{FF2B5EF4-FFF2-40B4-BE49-F238E27FC236}">
                <a16:creationId xmlns:a16="http://schemas.microsoft.com/office/drawing/2014/main" id="{838498E8-02B7-AF63-11EE-262CDE640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6" name="Plassholder for bunntekst 5">
            <a:extLst>
              <a:ext uri="{FF2B5EF4-FFF2-40B4-BE49-F238E27FC236}">
                <a16:creationId xmlns:a16="http://schemas.microsoft.com/office/drawing/2014/main" id="{E702548E-7F32-533D-7177-360FA936F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>
            <a:extLst>
              <a:ext uri="{FF2B5EF4-FFF2-40B4-BE49-F238E27FC236}">
                <a16:creationId xmlns:a16="http://schemas.microsoft.com/office/drawing/2014/main" id="{F8B8E318-FEA4-92E1-0454-EFF3574AD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82596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>
            <a:extLst>
              <a:ext uri="{FF2B5EF4-FFF2-40B4-BE49-F238E27FC236}">
                <a16:creationId xmlns:a16="http://schemas.microsoft.com/office/drawing/2014/main" id="{541591A6-C428-DA34-5F78-2A706C3E0A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</a:p>
        </p:txBody>
      </p:sp>
      <p:sp>
        <p:nvSpPr>
          <p:cNvPr id="3" name="Plassholder for tekst 2">
            <a:extLst>
              <a:ext uri="{FF2B5EF4-FFF2-40B4-BE49-F238E27FC236}">
                <a16:creationId xmlns:a16="http://schemas.microsoft.com/office/drawing/2014/main" id="{CC94E930-A001-22A7-CD54-03660D2FD6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</a:p>
        </p:txBody>
      </p:sp>
      <p:sp>
        <p:nvSpPr>
          <p:cNvPr id="4" name="Plassholder for dato 3">
            <a:extLst>
              <a:ext uri="{FF2B5EF4-FFF2-40B4-BE49-F238E27FC236}">
                <a16:creationId xmlns:a16="http://schemas.microsoft.com/office/drawing/2014/main" id="{953C32A9-4597-9109-5D23-F83D0AE1201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7DB17-5D0B-4840-8B07-A0D8D41CB8D3}" type="datetimeFigureOut">
              <a:rPr lang="nb-NO" smtClean="0"/>
              <a:t>08.08.2024</a:t>
            </a:fld>
            <a:endParaRPr lang="nb-NO"/>
          </a:p>
        </p:txBody>
      </p:sp>
      <p:sp>
        <p:nvSpPr>
          <p:cNvPr id="5" name="Plassholder for bunntekst 4">
            <a:extLst>
              <a:ext uri="{FF2B5EF4-FFF2-40B4-BE49-F238E27FC236}">
                <a16:creationId xmlns:a16="http://schemas.microsoft.com/office/drawing/2014/main" id="{56D46B84-3924-E822-E7FD-DFFA4CAFF5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>
            <a:extLst>
              <a:ext uri="{FF2B5EF4-FFF2-40B4-BE49-F238E27FC236}">
                <a16:creationId xmlns:a16="http://schemas.microsoft.com/office/drawing/2014/main" id="{3E77C6E7-88FA-B208-0F73-FD07E8269B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761F47-C969-43E1-96EE-6C747EE0E631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193142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kstSylinder 22">
            <a:extLst>
              <a:ext uri="{FF2B5EF4-FFF2-40B4-BE49-F238E27FC236}">
                <a16:creationId xmlns:a16="http://schemas.microsoft.com/office/drawing/2014/main" id="{F3A93F00-00D8-CC35-F45A-4F6EFABD0E5F}"/>
              </a:ext>
            </a:extLst>
          </p:cNvPr>
          <p:cNvSpPr txBox="1"/>
          <p:nvPr/>
        </p:nvSpPr>
        <p:spPr>
          <a:xfrm>
            <a:off x="1364778" y="56827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A</a:t>
            </a:r>
          </a:p>
        </p:txBody>
      </p:sp>
      <p:sp>
        <p:nvSpPr>
          <p:cNvPr id="25" name="TekstSylinder 24">
            <a:extLst>
              <a:ext uri="{FF2B5EF4-FFF2-40B4-BE49-F238E27FC236}">
                <a16:creationId xmlns:a16="http://schemas.microsoft.com/office/drawing/2014/main" id="{6B79FEF3-3B44-47A5-A68E-002FA5A93F14}"/>
              </a:ext>
            </a:extLst>
          </p:cNvPr>
          <p:cNvSpPr txBox="1"/>
          <p:nvPr/>
        </p:nvSpPr>
        <p:spPr>
          <a:xfrm>
            <a:off x="3919311" y="564843"/>
            <a:ext cx="690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dirty="0"/>
              <a:t>B</a:t>
            </a:r>
          </a:p>
        </p:txBody>
      </p:sp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F7702001-5F96-A580-F9AD-8CF8437605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77666818"/>
              </p:ext>
            </p:extLst>
          </p:nvPr>
        </p:nvGraphicFramePr>
        <p:xfrm>
          <a:off x="1327068" y="984782"/>
          <a:ext cx="2032000" cy="30400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2032246" imgH="3040060" progId="Prism9.Document">
                  <p:embed/>
                </p:oleObj>
              </mc:Choice>
              <mc:Fallback>
                <p:oleObj name="Prism 9" r:id="rId3" imgW="2032246" imgH="3040060" progId="Prism9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F7702001-5F96-A580-F9AD-8CF84376054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27068" y="984782"/>
                        <a:ext cx="2032000" cy="30400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>
            <a:extLst>
              <a:ext uri="{FF2B5EF4-FFF2-40B4-BE49-F238E27FC236}">
                <a16:creationId xmlns:a16="http://schemas.microsoft.com/office/drawing/2014/main" id="{CBD15462-B866-9679-24DB-768152745D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0655837"/>
              </p:ext>
            </p:extLst>
          </p:nvPr>
        </p:nvGraphicFramePr>
        <p:xfrm>
          <a:off x="3862190" y="760944"/>
          <a:ext cx="2032000" cy="3263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2032246" imgH="3264436" progId="Prism9.Document">
                  <p:embed/>
                </p:oleObj>
              </mc:Choice>
              <mc:Fallback>
                <p:oleObj name="Prism 9" r:id="rId5" imgW="2032246" imgH="3264436" progId="Prism9.Document">
                  <p:embed/>
                  <p:pic>
                    <p:nvPicPr>
                      <p:cNvPr id="11" name="Objekt 10">
                        <a:extLst>
                          <a:ext uri="{FF2B5EF4-FFF2-40B4-BE49-F238E27FC236}">
                            <a16:creationId xmlns:a16="http://schemas.microsoft.com/office/drawing/2014/main" id="{CBD15462-B866-9679-24DB-768152745DD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62190" y="760944"/>
                        <a:ext cx="2032000" cy="3263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kstSylinder 3">
            <a:extLst>
              <a:ext uri="{FF2B5EF4-FFF2-40B4-BE49-F238E27FC236}">
                <a16:creationId xmlns:a16="http://schemas.microsoft.com/office/drawing/2014/main" id="{E4E505C2-DB89-F483-8D73-18FB413F1FE8}"/>
              </a:ext>
            </a:extLst>
          </p:cNvPr>
          <p:cNvSpPr txBox="1"/>
          <p:nvPr/>
        </p:nvSpPr>
        <p:spPr>
          <a:xfrm>
            <a:off x="2849698" y="195511"/>
            <a:ext cx="1415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/>
              <a:t>Residual sera</a:t>
            </a:r>
          </a:p>
        </p:txBody>
      </p:sp>
      <p:sp>
        <p:nvSpPr>
          <p:cNvPr id="5" name="TekstSylinder 4">
            <a:extLst>
              <a:ext uri="{FF2B5EF4-FFF2-40B4-BE49-F238E27FC236}">
                <a16:creationId xmlns:a16="http://schemas.microsoft.com/office/drawing/2014/main" id="{8135F35A-62DC-86F2-E398-53B19E445A6E}"/>
              </a:ext>
            </a:extLst>
          </p:cNvPr>
          <p:cNvSpPr txBox="1"/>
          <p:nvPr/>
        </p:nvSpPr>
        <p:spPr>
          <a:xfrm>
            <a:off x="905902" y="4512851"/>
            <a:ext cx="8866747" cy="17377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US" sz="1100" b="1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Antibody levels and age-distribution in subgroups of residual sera analyzed by neutralization assays. 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e subgroups manually were selected based on their RBD-ACE2 interaction assay results: Inhibition of both Wuhan (W) and Omicron BA.2 (BA2) type interaction (W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2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, inhibition of W and not BA.2 (W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2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and inhibition of BA.2, but not W (W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A2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r>
              <a:rPr lang="en-US" sz="1100" kern="100" baseline="30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=20 for each group. A) Antibodies specific for nucleocapsid (N) in the three subgroups. Values are given as </a:t>
            </a:r>
            <a:r>
              <a:rPr lang="en-US" sz="1100" kern="1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MFI</a:t>
            </a:r>
            <a:r>
              <a:rPr lang="en-US" sz="1100" kern="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C) Age distribution of the subgroups. Dots indicate individual samples, and the horizontal lines represent the medians. n=20 for each group. *p&lt;0.05, **p&lt; 0.01, ****p&lt; 0.0001. ns=not significant. </a:t>
            </a:r>
            <a:endParaRPr lang="nb-NO" sz="1400" kern="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003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52A0FDAB0C7C884A950652628E07F3E6" ma:contentTypeVersion="20" ma:contentTypeDescription="Opprett et nytt dokument." ma:contentTypeScope="" ma:versionID="21687fabe6b49ba4b82bdd0bb9df9104">
  <xsd:schema xmlns:xsd="http://www.w3.org/2001/XMLSchema" xmlns:xs="http://www.w3.org/2001/XMLSchema" xmlns:p="http://schemas.microsoft.com/office/2006/metadata/properties" xmlns:ns2="9e7c1b5f-6b93-4ee4-9fa2-fda8f1b47cf5" xmlns:ns3="47c382fd-9ec6-40f8-a1b6-1c169c8fba98" xmlns:ns4="12a21d7c-cf9a-41d9-95d1-64d0c3908d52" targetNamespace="http://schemas.microsoft.com/office/2006/metadata/properties" ma:root="true" ma:fieldsID="767553a4dcdaa9cffc4c30e8b88738df" ns2:_="" ns3:_="" ns4:_="">
    <xsd:import namespace="9e7c1b5f-6b93-4ee4-9fa2-fda8f1b47cf5"/>
    <xsd:import namespace="47c382fd-9ec6-40f8-a1b6-1c169c8fba98"/>
    <xsd:import namespace="12a21d7c-cf9a-41d9-95d1-64d0c3908d52"/>
    <xsd:element name="properties">
      <xsd:complexType>
        <xsd:sequence>
          <xsd:element name="documentManagement">
            <xsd:complexType>
              <xsd:all>
                <xsd:element ref="ns2:FHI_TopicTaxHTField" minOccurs="0"/>
                <xsd:element ref="ns3:TaxCatchAll" minOccurs="0"/>
                <xsd:element ref="ns3:TaxKeywordTaxHTField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AutoTags" minOccurs="0"/>
                <xsd:element ref="ns4:MediaServiceOCR" minOccurs="0"/>
                <xsd:element ref="ns4:MediaServiceGenerationTime" minOccurs="0"/>
                <xsd:element ref="ns4:MediaServiceEventHashCode" minOccurs="0"/>
                <xsd:element ref="ns3:SharedWithUsers" minOccurs="0"/>
                <xsd:element ref="ns3:SharedWithDetails" minOccurs="0"/>
                <xsd:element ref="ns4:MediaServiceDateTaken" minOccurs="0"/>
                <xsd:element ref="ns4:lcf76f155ced4ddcb4097134ff3c332f" minOccurs="0"/>
                <xsd:element ref="ns4:MediaServiceObjectDetectorVersions" minOccurs="0"/>
                <xsd:element ref="ns4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e7c1b5f-6b93-4ee4-9fa2-fda8f1b47cf5" elementFormDefault="qualified">
    <xsd:import namespace="http://schemas.microsoft.com/office/2006/documentManagement/types"/>
    <xsd:import namespace="http://schemas.microsoft.com/office/infopath/2007/PartnerControls"/>
    <xsd:element name="FHI_TopicTaxHTField" ma:index="8" nillable="true" ma:taxonomy="true" ma:internalName="FHI_TopicTaxHTField" ma:taxonomyFieldName="FHI_Topic" ma:displayName="Tema" ma:default="1;#Virussykdommer|fb64bfef-7c21-43bd-a2fe-bc879f296443;#2;#Utbrudd|1d904ff4-3f61-4a6c-a150-748e518b56f3;#3;#Smittevern og vaksiner|595dfd2f-c3fd-4b72-9931-3d6eb156cad9" ma:fieldId="{5eb9fa72-8a58-4312-8bc5-a126a30b4fb3}" ma:taxonomyMulti="true" ma:sspId="e7140caa-8402-4c36-9a5d-f51276ec0a9c" ma:termSetId="10ab213d-8882-42de-b940-43a869fe753a" ma:anchorId="00000000-0000-0000-0000-000000000000" ma:open="fals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c382fd-9ec6-40f8-a1b6-1c169c8fba98" elementFormDefault="qualified">
    <xsd:import namespace="http://schemas.microsoft.com/office/2006/documentManagement/types"/>
    <xsd:import namespace="http://schemas.microsoft.com/office/infopath/2007/PartnerControls"/>
    <xsd:element name="TaxCatchAll" ma:index="10" nillable="true" ma:displayName="Taxonomy Catch All Column" ma:description="" ma:hidden="true" ma:list="{8d81fa7f-8fd7-4580-9607-57b994b6b2ce}" ma:internalName="TaxCatchAll" ma:showField="CatchAllData" ma:web="47c382fd-9ec6-40f8-a1b6-1c169c8fba9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TaxKeywordTaxHTField" ma:index="11" nillable="true" ma:taxonomy="true" ma:internalName="TaxKeywordTaxHTField" ma:taxonomyFieldName="TaxKeyword" ma:displayName="Organisasjonsnøkkelord" ma:fieldId="{23f27201-bee3-471e-b2e7-b64fd8b7ca38}" ma:taxonomyMulti="true" ma:sspId="e7140caa-8402-4c36-9a5d-f51276ec0a9c" ma:termSetId="00000000-0000-0000-0000-000000000000" ma:anchorId="00000000-0000-0000-0000-000000000000" ma:open="true" ma:isKeyword="true">
      <xsd:complexType>
        <xsd:sequence>
          <xsd:element ref="pc:Terms" minOccurs="0" maxOccurs="1"/>
        </xsd:sequence>
      </xsd:complexType>
    </xsd:element>
    <xsd:element name="SharedWithUsers" ma:index="21" nillable="true" ma:displayName="Delt med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lingsdetaljer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2a21d7c-cf9a-41d9-95d1-64d0c3908d5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3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4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3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5" nillable="true" ma:taxonomy="true" ma:internalName="lcf76f155ced4ddcb4097134ff3c332f" ma:taxonomyFieldName="MediaServiceImageTags" ma:displayName="Bildemerkelapper" ma:readOnly="false" ma:fieldId="{5cf76f15-5ced-4ddc-b409-7134ff3c332f}" ma:taxonomyMulti="true" ma:sspId="e7140caa-8402-4c36-9a5d-f51276ec0a9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holdstype"/>
        <xsd:element ref="dc:title" minOccurs="0" maxOccurs="1" ma:index="4" ma:displayName="Tit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12a21d7c-cf9a-41d9-95d1-64d0c3908d52">
      <Terms xmlns="http://schemas.microsoft.com/office/infopath/2007/PartnerControls"/>
    </lcf76f155ced4ddcb4097134ff3c332f>
    <TaxKeywordTaxHTField xmlns="47c382fd-9ec6-40f8-a1b6-1c169c8fba98">
      <Terms xmlns="http://schemas.microsoft.com/office/infopath/2007/PartnerControls"/>
    </TaxKeywordTaxHTField>
    <FHI_TopicTaxHTField xmlns="9e7c1b5f-6b93-4ee4-9fa2-fda8f1b47cf5">
      <Terms xmlns="http://schemas.microsoft.com/office/infopath/2007/PartnerControls">
        <TermInfo xmlns="http://schemas.microsoft.com/office/infopath/2007/PartnerControls">
          <TermName xmlns="http://schemas.microsoft.com/office/infopath/2007/PartnerControls">Virussykdommer</TermName>
          <TermId xmlns="http://schemas.microsoft.com/office/infopath/2007/PartnerControls">fb64bfef-7c21-43bd-a2fe-bc879f296443</TermId>
        </TermInfo>
        <TermInfo xmlns="http://schemas.microsoft.com/office/infopath/2007/PartnerControls">
          <TermName xmlns="http://schemas.microsoft.com/office/infopath/2007/PartnerControls">Utbrudd</TermName>
          <TermId xmlns="http://schemas.microsoft.com/office/infopath/2007/PartnerControls">1d904ff4-3f61-4a6c-a150-748e518b56f3</TermId>
        </TermInfo>
        <TermInfo xmlns="http://schemas.microsoft.com/office/infopath/2007/PartnerControls">
          <TermName xmlns="http://schemas.microsoft.com/office/infopath/2007/PartnerControls">Smittevern og vaksiner</TermName>
          <TermId xmlns="http://schemas.microsoft.com/office/infopath/2007/PartnerControls">595dfd2f-c3fd-4b72-9931-3d6eb156cad9</TermId>
        </TermInfo>
      </Terms>
    </FHI_TopicTaxHTField>
    <TaxCatchAll xmlns="47c382fd-9ec6-40f8-a1b6-1c169c8fba98">
      <Value>3</Value>
      <Value>2</Value>
      <Value>1</Value>
    </TaxCatchAll>
  </documentManagement>
</p:properties>
</file>

<file path=customXml/itemProps1.xml><?xml version="1.0" encoding="utf-8"?>
<ds:datastoreItem xmlns:ds="http://schemas.openxmlformats.org/officeDocument/2006/customXml" ds:itemID="{4E1A8C84-294D-42E0-8CEE-26BAEC5967D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e7c1b5f-6b93-4ee4-9fa2-fda8f1b47cf5"/>
    <ds:schemaRef ds:uri="47c382fd-9ec6-40f8-a1b6-1c169c8fba98"/>
    <ds:schemaRef ds:uri="12a21d7c-cf9a-41d9-95d1-64d0c3908d5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74250CB-A3B1-41D8-AB9F-9229DBA87E1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D78C611-CFFA-43E9-B303-301A6F2B63F3}">
  <ds:schemaRefs>
    <ds:schemaRef ds:uri="http://schemas.microsoft.com/office/2006/metadata/properties"/>
    <ds:schemaRef ds:uri="http://schemas.microsoft.com/office/infopath/2007/PartnerControls"/>
    <ds:schemaRef ds:uri="12a21d7c-cf9a-41d9-95d1-64d0c3908d52"/>
    <ds:schemaRef ds:uri="47c382fd-9ec6-40f8-a1b6-1c169c8fba98"/>
    <ds:schemaRef ds:uri="9e7c1b5f-6b93-4ee4-9fa2-fda8f1b47cf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9</Words>
  <Application>Microsoft Office PowerPoint</Application>
  <PresentationFormat>Widescreen</PresentationFormat>
  <Paragraphs>5</Paragraphs>
  <Slides>1</Slides>
  <Notes>1</Notes>
  <HiddenSlides>0</HiddenSlides>
  <MMClips>0</MMClips>
  <ScaleCrop>false</ScaleCrop>
  <HeadingPairs>
    <vt:vector size="8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Innebygde OLE-servere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Prism 9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Gro Tunheim</dc:creator>
  <cp:lastModifiedBy>Gro Tunheim</cp:lastModifiedBy>
  <cp:revision>2</cp:revision>
  <dcterms:created xsi:type="dcterms:W3CDTF">2023-09-28T09:19:32Z</dcterms:created>
  <dcterms:modified xsi:type="dcterms:W3CDTF">2024-08-08T12:27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2A0FDAB0C7C884A950652628E07F3E6</vt:lpwstr>
  </property>
  <property fmtid="{D5CDD505-2E9C-101B-9397-08002B2CF9AE}" pid="3" name="FHI_Topic">
    <vt:lpwstr>1;#Virussykdommer|fb64bfef-7c21-43bd-a2fe-bc879f296443;#2;#Utbrudd|1d904ff4-3f61-4a6c-a150-748e518b56f3;#3;#Smittevern og vaksiner|595dfd2f-c3fd-4b72-9931-3d6eb156cad9</vt:lpwstr>
  </property>
  <property fmtid="{D5CDD505-2E9C-101B-9397-08002B2CF9AE}" pid="4" name="TaxKeyword">
    <vt:lpwstr/>
  </property>
  <property fmtid="{D5CDD505-2E9C-101B-9397-08002B2CF9AE}" pid="5" name="MediaServiceImageTags">
    <vt:lpwstr/>
  </property>
</Properties>
</file>